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  <p:sldMasterId id="2147483684" r:id="rId5"/>
  </p:sldMasterIdLst>
  <p:sldIdLst>
    <p:sldId id="270" r:id="rId6"/>
  </p:sldIdLst>
  <p:sldSz cx="6858000" cy="9906000" type="A4"/>
  <p:notesSz cx="6858000" cy="9144000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66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1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microsoft.com/office/2016/11/relationships/changesInfo" Target="changesInfos/changesInfo1.xml"/><Relationship Id="rId5" Type="http://schemas.openxmlformats.org/officeDocument/2006/relationships/slideMaster" Target="slideMasters/slideMaster2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ichard Martin" userId="2c73e390-468f-42ee-a27d-0201611ba0d3" providerId="ADAL" clId="{7E53176E-28E0-4F24-BCF8-68B93ED6E18B}"/>
    <pc:docChg chg="modSld">
      <pc:chgData name="Richard Martin" userId="2c73e390-468f-42ee-a27d-0201611ba0d3" providerId="ADAL" clId="{7E53176E-28E0-4F24-BCF8-68B93ED6E18B}" dt="2022-10-14T22:14:04.674" v="1" actId="20577"/>
      <pc:docMkLst>
        <pc:docMk/>
      </pc:docMkLst>
      <pc:sldChg chg="modSp mod">
        <pc:chgData name="Richard Martin" userId="2c73e390-468f-42ee-a27d-0201611ba0d3" providerId="ADAL" clId="{7E53176E-28E0-4F24-BCF8-68B93ED6E18B}" dt="2022-10-14T22:14:04.674" v="1" actId="20577"/>
        <pc:sldMkLst>
          <pc:docMk/>
          <pc:sldMk cId="2209519731" sldId="270"/>
        </pc:sldMkLst>
        <pc:spChg chg="mod">
          <ac:chgData name="Richard Martin" userId="2c73e390-468f-42ee-a27d-0201611ba0d3" providerId="ADAL" clId="{7E53176E-28E0-4F24-BCF8-68B93ED6E18B}" dt="2022-10-14T22:14:04.674" v="1" actId="20577"/>
          <ac:spMkLst>
            <pc:docMk/>
            <pc:sldMk cId="2209519731" sldId="270"/>
            <ac:spMk id="63" creationId="{0FA638F6-5764-44C5-8B0A-AAA21E1A748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4" indent="0" algn="ctr">
              <a:buNone/>
              <a:defRPr sz="1500"/>
            </a:lvl2pPr>
            <a:lvl3pPr marL="685787" indent="0" algn="ctr">
              <a:buNone/>
              <a:defRPr sz="1350"/>
            </a:lvl3pPr>
            <a:lvl4pPr marL="1028681" indent="0" algn="ctr">
              <a:buNone/>
              <a:defRPr sz="1200"/>
            </a:lvl4pPr>
            <a:lvl5pPr marL="1371575" indent="0" algn="ctr">
              <a:buNone/>
              <a:defRPr sz="1200"/>
            </a:lvl5pPr>
            <a:lvl6pPr marL="1714468" indent="0" algn="ctr">
              <a:buNone/>
              <a:defRPr sz="1200"/>
            </a:lvl6pPr>
            <a:lvl7pPr marL="2057362" indent="0" algn="ctr">
              <a:buNone/>
              <a:defRPr sz="1200"/>
            </a:lvl7pPr>
            <a:lvl8pPr marL="2400256" indent="0" algn="ctr">
              <a:buNone/>
              <a:defRPr sz="1200"/>
            </a:lvl8pPr>
            <a:lvl9pPr marL="274315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09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083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202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09772-E514-45B9-8CF4-92DF4A613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0B107E-D851-4A12-AF94-3795778259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ED4F1-9F3A-456F-80DC-5DED50F7B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3F402-3486-4322-8248-4BAC83098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52FD9-FD18-4157-9687-A8A4A14A4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7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DA3B-973B-4351-A78A-50D6F2F52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C3936-2E45-47F5-88F3-CC0FBE8D5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3BC8E-2B2C-4037-83EA-D6DE8A5C7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022F1-9174-4AA9-9B99-05226159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E1F1A-C3FB-42B5-96B2-AA7DDB520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619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AF10E-E890-48B5-B9DA-7DB62C863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AC4CF-EB1B-4163-AB69-524FAC55F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6CEA9-E99A-48A1-9606-17174C45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D5-BB1E-4126-A0A8-E3E1A846B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13870-8824-49E0-9A21-3BF5A1F6B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6786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F9F-6256-443A-9A23-B42146D66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53B4-9221-49A7-A6E7-FCCEF6836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9B7275-D924-43C6-A4C7-66B557518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D0C1F-73DC-43E9-B48D-D786852B7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5FBBF-74A2-4E6B-BC75-1E37657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C51576-CC48-498E-8765-DE56DAE5A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643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3F30-C803-47E4-8347-5E602398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A377A-880F-4EC6-97FF-CAEBE1C58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F3534-8A8F-4D28-B44D-79D31C57D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E94583-C1AF-41D9-9033-6050FDE773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DEE9E9-1F08-4E9A-A20D-A5DF3777F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C1012B-0494-4A31-8816-3C5926416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BBDD3-2A6F-4A19-8A39-887DDC08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8116A3-8B03-4714-8830-66560B948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74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28F8-CF4E-488A-93AF-1BC5118B8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4E3929-5A95-436D-B902-CE72CF6B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AB1B8-0FA4-41DE-BD94-D5A883C1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5A80C-9A52-4647-A2A9-6F6FB9C3A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8155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E630A6-7184-47A2-9972-68A98471D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C77312-F2DE-4132-9397-D1479592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088FC-332A-4E9A-9CD0-BB20FAD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09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8BCF8-8542-4164-8762-60C12241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8C008-472E-4C2E-A842-76D1B9F721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3FB18-C304-4CC4-9A13-ED8C38F16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B6FC1-91E3-4769-A0B1-C0DCC4B70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6C68DB-9C40-4AE0-96F4-82A16DC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ABE2B-7320-4B70-8DF1-4A75C7D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4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080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E560F-FBA5-4A57-BAAB-B5B245A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6DF3D-976B-41C0-8413-E44AB3443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9E36D-E537-456F-A46E-D956F8FA29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EBEAB-7AD1-4AC6-8783-9A3BFDD6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D40531-89C0-454E-A9D7-6412C7CC6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01019-E7CE-47CA-92FF-7434AF3B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735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23F2D-2D6D-4BF4-96F3-A38D85AA6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284063-D278-4428-A223-48C303113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DE4D9-9DFD-4B19-9A4B-F4A9711AF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F7B78-D83E-482B-8423-D48D005E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AAD84-DF58-4E58-B84B-940D4E858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854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FD37CB-620B-4C5A-886D-763C2B493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B42B9-5DBB-4588-803A-5E31F1002E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8DE5B-9C7F-4C6C-88C6-A7DE08E4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ABC10-CB61-4AD4-A91B-39588FE54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5FAA9-D874-44EA-9C94-8FF9115E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3901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165A-EB3D-4DE9-956A-6302BF27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D5DFB-FAC6-419C-B452-9ED84B38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69401A-86BB-478E-8EE9-747E0FDF4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C80AC-60F4-4902-9B12-604D07091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2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6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3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1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8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9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3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4" indent="0">
              <a:buNone/>
              <a:defRPr sz="2100"/>
            </a:lvl2pPr>
            <a:lvl3pPr marL="685787" indent="0">
              <a:buNone/>
              <a:defRPr sz="1800"/>
            </a:lvl3pPr>
            <a:lvl4pPr marL="1028681" indent="0">
              <a:buNone/>
              <a:defRPr sz="1500"/>
            </a:lvl4pPr>
            <a:lvl5pPr marL="1371575" indent="0">
              <a:buNone/>
              <a:defRPr sz="1500"/>
            </a:lvl5pPr>
            <a:lvl6pPr marL="1714468" indent="0">
              <a:buNone/>
              <a:defRPr sz="1500"/>
            </a:lvl6pPr>
            <a:lvl7pPr marL="2057362" indent="0">
              <a:buNone/>
              <a:defRPr sz="1500"/>
            </a:lvl7pPr>
            <a:lvl8pPr marL="2400256" indent="0">
              <a:buNone/>
              <a:defRPr sz="1500"/>
            </a:lvl8pPr>
            <a:lvl9pPr marL="274315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FB57F-F3C2-44F1-BDA1-59B168DF83F1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50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7" indent="-171447" algn="l" defTabSz="68578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1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34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8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22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15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09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03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97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4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7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81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75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68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62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56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5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EA7FF-5392-453F-B97E-628C7A069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0A679-CADD-47AC-953E-FE520426F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9E62A-4952-4FF1-8805-218D38711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23A10-7854-46EF-8C3E-A0D0F7144EA0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94C13-E29D-41AC-93DC-B46213509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B7D7B-27F5-48A9-AB98-28A54E3D8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0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684E322A-4B48-401C-AC5F-F2CC3F791678}"/>
              </a:ext>
            </a:extLst>
          </p:cNvPr>
          <p:cNvSpPr txBox="1"/>
          <p:nvPr/>
        </p:nvSpPr>
        <p:spPr>
          <a:xfrm>
            <a:off x="1097736" y="707510"/>
            <a:ext cx="329645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8DEF180-11BB-411E-AC87-9880271C1087}"/>
              </a:ext>
            </a:extLst>
          </p:cNvPr>
          <p:cNvSpPr txBox="1"/>
          <p:nvPr/>
        </p:nvSpPr>
        <p:spPr>
          <a:xfrm>
            <a:off x="1104374" y="5196314"/>
            <a:ext cx="329645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39C7886-0FF4-442E-AB6D-BC01F2CB9442}"/>
              </a:ext>
            </a:extLst>
          </p:cNvPr>
          <p:cNvSpPr txBox="1"/>
          <p:nvPr/>
        </p:nvSpPr>
        <p:spPr>
          <a:xfrm>
            <a:off x="2219199" y="5037720"/>
            <a:ext cx="235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scle Bag Region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52C4D02-396E-4EE8-B901-B0A25331F632}"/>
              </a:ext>
            </a:extLst>
          </p:cNvPr>
          <p:cNvGrpSpPr/>
          <p:nvPr/>
        </p:nvGrpSpPr>
        <p:grpSpPr>
          <a:xfrm>
            <a:off x="1128026" y="640496"/>
            <a:ext cx="4191329" cy="4091210"/>
            <a:chOff x="1128026" y="310296"/>
            <a:chExt cx="4191329" cy="4091210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C4DA30B-18D4-4854-8EC5-87E5B4364EAE}"/>
                </a:ext>
              </a:extLst>
            </p:cNvPr>
            <p:cNvSpPr txBox="1"/>
            <p:nvPr/>
          </p:nvSpPr>
          <p:spPr>
            <a:xfrm rot="18650546">
              <a:off x="426598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0281D48-9EF8-48DC-AA3C-B48D1AB856AE}"/>
                </a:ext>
              </a:extLst>
            </p:cNvPr>
            <p:cNvSpPr txBox="1"/>
            <p:nvPr/>
          </p:nvSpPr>
          <p:spPr>
            <a:xfrm rot="18650546">
              <a:off x="365638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5448D30-9398-4D53-9F12-774181A83A1C}"/>
                </a:ext>
              </a:extLst>
            </p:cNvPr>
            <p:cNvSpPr txBox="1"/>
            <p:nvPr/>
          </p:nvSpPr>
          <p:spPr>
            <a:xfrm rot="18650546">
              <a:off x="305440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EA9A797A-9D10-4AE7-862F-8817B6BB1620}"/>
                </a:ext>
              </a:extLst>
            </p:cNvPr>
            <p:cNvSpPr txBox="1"/>
            <p:nvPr/>
          </p:nvSpPr>
          <p:spPr>
            <a:xfrm rot="18650546">
              <a:off x="246004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AC7AE0C-C00C-4514-9958-05D8DA997E9C}"/>
                </a:ext>
              </a:extLst>
            </p:cNvPr>
            <p:cNvSpPr txBox="1"/>
            <p:nvPr/>
          </p:nvSpPr>
          <p:spPr>
            <a:xfrm rot="18650546">
              <a:off x="185044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E3CDA68-E39C-4971-B18C-3E6729B5FA35}"/>
                </a:ext>
              </a:extLst>
            </p:cNvPr>
            <p:cNvSpPr txBox="1"/>
            <p:nvPr/>
          </p:nvSpPr>
          <p:spPr>
            <a:xfrm rot="18650546">
              <a:off x="1256088" y="3835736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A33653E-3113-4873-AB6F-B484C42F29E4}"/>
                </a:ext>
              </a:extLst>
            </p:cNvPr>
            <p:cNvSpPr txBox="1"/>
            <p:nvPr/>
          </p:nvSpPr>
          <p:spPr>
            <a:xfrm rot="18650546">
              <a:off x="1545073" y="385887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58F966C-317F-4D3A-9BFD-455B88536E3C}"/>
                </a:ext>
              </a:extLst>
            </p:cNvPr>
            <p:cNvSpPr txBox="1"/>
            <p:nvPr/>
          </p:nvSpPr>
          <p:spPr>
            <a:xfrm rot="18650546">
              <a:off x="2124193" y="385887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47E8EC0-84EC-4F2A-9CE1-AC542877525A}"/>
                </a:ext>
              </a:extLst>
            </p:cNvPr>
            <p:cNvSpPr txBox="1"/>
            <p:nvPr/>
          </p:nvSpPr>
          <p:spPr>
            <a:xfrm rot="18650546">
              <a:off x="2741413" y="385125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5D1E504-500C-4274-AC43-4217E1FE799C}"/>
                </a:ext>
              </a:extLst>
            </p:cNvPr>
            <p:cNvSpPr txBox="1"/>
            <p:nvPr/>
          </p:nvSpPr>
          <p:spPr>
            <a:xfrm rot="18650546">
              <a:off x="3328153" y="385887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415A5F0-83EF-4D05-8F29-C209EE4F9BE4}"/>
                </a:ext>
              </a:extLst>
            </p:cNvPr>
            <p:cNvSpPr txBox="1"/>
            <p:nvPr/>
          </p:nvSpPr>
          <p:spPr>
            <a:xfrm rot="18650546">
              <a:off x="3922513" y="385887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EB6EF0A-8071-446C-93F0-6BA1C30220BD}"/>
                </a:ext>
              </a:extLst>
            </p:cNvPr>
            <p:cNvSpPr txBox="1"/>
            <p:nvPr/>
          </p:nvSpPr>
          <p:spPr>
            <a:xfrm rot="18650546">
              <a:off x="4524493" y="385887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238252" y="561912"/>
              <a:ext cx="4016879" cy="3339127"/>
              <a:chOff x="1238252" y="657337"/>
              <a:chExt cx="4016879" cy="3339127"/>
            </a:xfrm>
          </p:grpSpPr>
          <p:graphicFrame>
            <p:nvGraphicFramePr>
              <p:cNvPr id="30" name="Object 29"/>
              <p:cNvGraphicFramePr>
                <a:graphicFrameLocks noChangeAspect="1"/>
              </p:cNvGraphicFramePr>
              <p:nvPr/>
            </p:nvGraphicFramePr>
            <p:xfrm>
              <a:off x="1548224" y="657337"/>
              <a:ext cx="3706907" cy="33013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2" imgW="6588000" imgH="5868000" progId="Prism5.Document">
                      <p:embed/>
                    </p:oleObj>
                  </mc:Choice>
                  <mc:Fallback>
                    <p:oleObj name="Prism Project" r:id="rId2" imgW="6588000" imgH="5868000" progId="Prism5.Document">
                      <p:embed/>
                      <p:pic>
                        <p:nvPicPr>
                          <p:cNvPr id="30" name="Object 29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548224" y="657337"/>
                            <a:ext cx="3706907" cy="33013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431677" y="3719465"/>
                <a:ext cx="2105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239682" y="2957843"/>
                <a:ext cx="4617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434364" y="2190534"/>
                <a:ext cx="2105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238252" y="1426940"/>
                <a:ext cx="4554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421664" y="662724"/>
                <a:ext cx="2105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3A7CDC6-35C1-4273-9483-D74758F9A359}"/>
                </a:ext>
              </a:extLst>
            </p:cNvPr>
            <p:cNvSpPr txBox="1"/>
            <p:nvPr/>
          </p:nvSpPr>
          <p:spPr>
            <a:xfrm>
              <a:off x="2568338" y="310296"/>
              <a:ext cx="16580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testine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DCB8FB0-2B12-48AE-B80A-95D188E52C2B}"/>
                </a:ext>
              </a:extLst>
            </p:cNvPr>
            <p:cNvSpPr txBox="1"/>
            <p:nvPr/>
          </p:nvSpPr>
          <p:spPr>
            <a:xfrm rot="16200000">
              <a:off x="612388" y="2083381"/>
              <a:ext cx="13390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1607134" y="2236946"/>
              <a:ext cx="360641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7DEBA10-9A30-456B-98F1-92AB61C7ADB3}"/>
                </a:ext>
              </a:extLst>
            </p:cNvPr>
            <p:cNvSpPr txBox="1"/>
            <p:nvPr/>
          </p:nvSpPr>
          <p:spPr>
            <a:xfrm>
              <a:off x="3269968" y="4136644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OCR-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08D7F02-4ACB-46B0-B474-5E81BC414657}"/>
                </a:ext>
              </a:extLst>
            </p:cNvPr>
            <p:cNvSpPr txBox="1"/>
            <p:nvPr/>
          </p:nvSpPr>
          <p:spPr>
            <a:xfrm>
              <a:off x="3879332" y="4137198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OSM-9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8F82E5B-903A-4C5F-85E7-9FDB65C5B31D}"/>
                </a:ext>
              </a:extLst>
            </p:cNvPr>
            <p:cNvSpPr txBox="1"/>
            <p:nvPr/>
          </p:nvSpPr>
          <p:spPr>
            <a:xfrm>
              <a:off x="4464928" y="4137017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RPA-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0405AFF-5D8D-4F8A-AC50-20625B129839}"/>
                </a:ext>
              </a:extLst>
            </p:cNvPr>
            <p:cNvSpPr txBox="1"/>
            <p:nvPr/>
          </p:nvSpPr>
          <p:spPr>
            <a:xfrm>
              <a:off x="2075160" y="4136496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RP-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229E472-3EDA-475C-81BF-9FA92B7D42D3}"/>
                </a:ext>
              </a:extLst>
            </p:cNvPr>
            <p:cNvSpPr txBox="1"/>
            <p:nvPr/>
          </p:nvSpPr>
          <p:spPr>
            <a:xfrm>
              <a:off x="1480800" y="4136496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GON-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11B0498-2CEA-4C22-92BC-E04C608186DF}"/>
                </a:ext>
              </a:extLst>
            </p:cNvPr>
            <p:cNvSpPr txBox="1"/>
            <p:nvPr/>
          </p:nvSpPr>
          <p:spPr>
            <a:xfrm>
              <a:off x="2676063" y="4136496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ED-11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E5E32DC5-8CCD-4C8B-8569-7C08987FBE54}"/>
              </a:ext>
            </a:extLst>
          </p:cNvPr>
          <p:cNvGrpSpPr/>
          <p:nvPr/>
        </p:nvGrpSpPr>
        <p:grpSpPr>
          <a:xfrm>
            <a:off x="1048892" y="5334884"/>
            <a:ext cx="4278083" cy="3847253"/>
            <a:chOff x="1048892" y="4607644"/>
            <a:chExt cx="4278083" cy="3847253"/>
          </a:xfrm>
        </p:grpSpPr>
        <p:grpSp>
          <p:nvGrpSpPr>
            <p:cNvPr id="2" name="Group 1"/>
            <p:cNvGrpSpPr/>
            <p:nvPr/>
          </p:nvGrpSpPr>
          <p:grpSpPr>
            <a:xfrm>
              <a:off x="1212851" y="4607644"/>
              <a:ext cx="4042280" cy="3348142"/>
              <a:chOff x="1220471" y="4601643"/>
              <a:chExt cx="4042280" cy="3348142"/>
            </a:xfrm>
          </p:grpSpPr>
          <p:graphicFrame>
            <p:nvGraphicFramePr>
              <p:cNvPr id="10" name="Object 9"/>
              <p:cNvGraphicFramePr>
                <a:graphicFrameLocks noChangeAspect="1"/>
              </p:cNvGraphicFramePr>
              <p:nvPr/>
            </p:nvGraphicFramePr>
            <p:xfrm>
              <a:off x="1555844" y="4601643"/>
              <a:ext cx="3706907" cy="33013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4" imgW="6588000" imgH="5868000" progId="Prism5.Document">
                      <p:embed/>
                    </p:oleObj>
                  </mc:Choice>
                  <mc:Fallback>
                    <p:oleObj name="Prism Project" r:id="rId4" imgW="6588000" imgH="5868000" progId="Prism5.Document">
                      <p:embed/>
                      <p:pic>
                        <p:nvPicPr>
                          <p:cNvPr id="10" name="Object 9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555844" y="4601643"/>
                            <a:ext cx="3706907" cy="33013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394063" y="7672786"/>
                <a:ext cx="2581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220471" y="6915865"/>
                <a:ext cx="4512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390253" y="6142759"/>
                <a:ext cx="2581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226821" y="5372815"/>
                <a:ext cx="4512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E1F7ED6-07CF-413A-B531-4479D8E4B408}"/>
                  </a:ext>
                </a:extLst>
              </p:cNvPr>
              <p:cNvSpPr txBox="1"/>
              <p:nvPr/>
            </p:nvSpPr>
            <p:spPr>
              <a:xfrm>
                <a:off x="1390253" y="4614949"/>
                <a:ext cx="2581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DCB8FB0-2B12-48AE-B80A-95D188E52C2B}"/>
                </a:ext>
              </a:extLst>
            </p:cNvPr>
            <p:cNvSpPr txBox="1"/>
            <p:nvPr/>
          </p:nvSpPr>
          <p:spPr>
            <a:xfrm rot="16200000">
              <a:off x="533254" y="6125933"/>
              <a:ext cx="13390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1607134" y="6279821"/>
              <a:ext cx="360641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808B961-D75C-4A65-8F6F-1FEBB389040F}"/>
                </a:ext>
              </a:extLst>
            </p:cNvPr>
            <p:cNvSpPr txBox="1"/>
            <p:nvPr/>
          </p:nvSpPr>
          <p:spPr>
            <a:xfrm rot="18650546">
              <a:off x="427360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8B041DB2-FB9B-429D-BC44-D1B01D8D4EB3}"/>
                </a:ext>
              </a:extLst>
            </p:cNvPr>
            <p:cNvSpPr txBox="1"/>
            <p:nvPr/>
          </p:nvSpPr>
          <p:spPr>
            <a:xfrm rot="18650546">
              <a:off x="366400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2A879D9-CD28-4494-BA16-D7BECD1D19A8}"/>
                </a:ext>
              </a:extLst>
            </p:cNvPr>
            <p:cNvSpPr txBox="1"/>
            <p:nvPr/>
          </p:nvSpPr>
          <p:spPr>
            <a:xfrm rot="18650546">
              <a:off x="306202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EF6A144-6F69-45E9-9B93-BAAE6E269698}"/>
                </a:ext>
              </a:extLst>
            </p:cNvPr>
            <p:cNvSpPr txBox="1"/>
            <p:nvPr/>
          </p:nvSpPr>
          <p:spPr>
            <a:xfrm rot="18650546">
              <a:off x="246766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1EEA680A-D25B-46E9-BECF-905238E73ADE}"/>
                </a:ext>
              </a:extLst>
            </p:cNvPr>
            <p:cNvSpPr txBox="1"/>
            <p:nvPr/>
          </p:nvSpPr>
          <p:spPr>
            <a:xfrm rot="18650546">
              <a:off x="185806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53A6906-35BE-4F02-8402-7BC65DA036DA}"/>
                </a:ext>
              </a:extLst>
            </p:cNvPr>
            <p:cNvSpPr txBox="1"/>
            <p:nvPr/>
          </p:nvSpPr>
          <p:spPr>
            <a:xfrm rot="18650546">
              <a:off x="1263708" y="7889127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034E784-A294-4E14-8D67-809DB18A641F}"/>
                </a:ext>
              </a:extLst>
            </p:cNvPr>
            <p:cNvSpPr txBox="1"/>
            <p:nvPr/>
          </p:nvSpPr>
          <p:spPr>
            <a:xfrm rot="18650546">
              <a:off x="1552693" y="791226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12476041-E91B-4F36-952E-89C665A7D197}"/>
                </a:ext>
              </a:extLst>
            </p:cNvPr>
            <p:cNvSpPr txBox="1"/>
            <p:nvPr/>
          </p:nvSpPr>
          <p:spPr>
            <a:xfrm rot="18650546">
              <a:off x="2131813" y="791226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560128F-AA29-4755-AE8E-89434345D98C}"/>
                </a:ext>
              </a:extLst>
            </p:cNvPr>
            <p:cNvSpPr txBox="1"/>
            <p:nvPr/>
          </p:nvSpPr>
          <p:spPr>
            <a:xfrm rot="18650546">
              <a:off x="2749033" y="790464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1209154-2B50-49B7-8C82-BFF14115A316}"/>
                </a:ext>
              </a:extLst>
            </p:cNvPr>
            <p:cNvSpPr txBox="1"/>
            <p:nvPr/>
          </p:nvSpPr>
          <p:spPr>
            <a:xfrm rot="18650546">
              <a:off x="3335773" y="791226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E539B3F-E1E2-4391-8B3B-2902F2701CF6}"/>
                </a:ext>
              </a:extLst>
            </p:cNvPr>
            <p:cNvSpPr txBox="1"/>
            <p:nvPr/>
          </p:nvSpPr>
          <p:spPr>
            <a:xfrm rot="18650546">
              <a:off x="3930133" y="791226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2663BC60-A2F2-4375-B366-BE4E9A789C29}"/>
                </a:ext>
              </a:extLst>
            </p:cNvPr>
            <p:cNvSpPr txBox="1"/>
            <p:nvPr/>
          </p:nvSpPr>
          <p:spPr>
            <a:xfrm rot="18650546">
              <a:off x="4532113" y="7912268"/>
              <a:ext cx="85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FCA7556-C212-4ABF-B085-40FC7381B2A3}"/>
                </a:ext>
              </a:extLst>
            </p:cNvPr>
            <p:cNvSpPr txBox="1"/>
            <p:nvPr/>
          </p:nvSpPr>
          <p:spPr>
            <a:xfrm>
              <a:off x="3277588" y="8190035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OCR-1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1B1C810C-8068-48FB-BD67-28FB6802D6E7}"/>
                </a:ext>
              </a:extLst>
            </p:cNvPr>
            <p:cNvSpPr txBox="1"/>
            <p:nvPr/>
          </p:nvSpPr>
          <p:spPr>
            <a:xfrm>
              <a:off x="3886952" y="8190589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OSM-9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3370E48-95C8-4356-B33A-D69BAB83ADBE}"/>
                </a:ext>
              </a:extLst>
            </p:cNvPr>
            <p:cNvSpPr txBox="1"/>
            <p:nvPr/>
          </p:nvSpPr>
          <p:spPr>
            <a:xfrm>
              <a:off x="4472548" y="8190408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RPA-1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759CF140-934D-4C41-9D8F-798C4D15C063}"/>
                </a:ext>
              </a:extLst>
            </p:cNvPr>
            <p:cNvSpPr txBox="1"/>
            <p:nvPr/>
          </p:nvSpPr>
          <p:spPr>
            <a:xfrm>
              <a:off x="2082780" y="8189887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RP-2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CAEBF59A-B957-4B8F-B5CA-DF81447B8DD0}"/>
                </a:ext>
              </a:extLst>
            </p:cNvPr>
            <p:cNvSpPr txBox="1"/>
            <p:nvPr/>
          </p:nvSpPr>
          <p:spPr>
            <a:xfrm>
              <a:off x="1488420" y="8189887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GON-2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7F3DC5B-6178-4398-8A35-F5E11672D494}"/>
                </a:ext>
              </a:extLst>
            </p:cNvPr>
            <p:cNvSpPr txBox="1"/>
            <p:nvPr/>
          </p:nvSpPr>
          <p:spPr>
            <a:xfrm>
              <a:off x="2683683" y="8189887"/>
              <a:ext cx="8544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ED-11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0FA638F6-5764-44C5-8B0A-AAA21E1A7481}"/>
              </a:ext>
            </a:extLst>
          </p:cNvPr>
          <p:cNvSpPr txBox="1"/>
          <p:nvPr/>
        </p:nvSpPr>
        <p:spPr>
          <a:xfrm>
            <a:off x="57126" y="-24015"/>
            <a:ext cx="2501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9519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386C19394DC8445AE088940873BA13C" ma:contentTypeVersion="13" ma:contentTypeDescription="Create a new document." ma:contentTypeScope="" ma:versionID="0f11dac1416f3fc84ab80c4571d56544">
  <xsd:schema xmlns:xsd="http://www.w3.org/2001/XMLSchema" xmlns:xs="http://www.w3.org/2001/XMLSchema" xmlns:p="http://schemas.microsoft.com/office/2006/metadata/properties" xmlns:ns3="602df715-3c1c-4141-9740-0b7bc9b7e8e8" xmlns:ns4="e29bde89-9ee1-4d11-90f1-fe7b6b3b563b" targetNamespace="http://schemas.microsoft.com/office/2006/metadata/properties" ma:root="true" ma:fieldsID="0aae18bf36475026346c8d984fb73d8e" ns3:_="" ns4:_="">
    <xsd:import namespace="602df715-3c1c-4141-9740-0b7bc9b7e8e8"/>
    <xsd:import namespace="e29bde89-9ee1-4d11-90f1-fe7b6b3b563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3:SharedWithDetails" minOccurs="0"/>
                <xsd:element ref="ns3:SharingHintHash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2df715-3c1c-4141-9740-0b7bc9b7e8e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9bde89-9ee1-4d11-90f1-fe7b6b3b563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8A50CD0C-862F-4B78-ADDF-487BFDDD911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6238409-CCA8-4A2C-805F-F8BA25FEC1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02df715-3c1c-4141-9740-0b7bc9b7e8e8"/>
    <ds:schemaRef ds:uri="e29bde89-9ee1-4d11-90f1-fe7b6b3b563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E2C4DDE-2D9D-4569-9281-E09F6F263835}">
  <ds:schemaRefs>
    <ds:schemaRef ds:uri="http://schemas.microsoft.com/office/2006/metadata/properties"/>
    <ds:schemaRef ds:uri="602df715-3c1c-4141-9740-0b7bc9b7e8e8"/>
    <ds:schemaRef ds:uri="http://schemas.microsoft.com/office/2006/documentManagement/types"/>
    <ds:schemaRef ds:uri="http://purl.org/dc/elements/1.1/"/>
    <ds:schemaRef ds:uri="http://purl.org/dc/dcmitype/"/>
    <ds:schemaRef ds:uri="http://purl.org/dc/terms/"/>
    <ds:schemaRef ds:uri="e29bde89-9ee1-4d11-90f1-fe7b6b3b563b"/>
    <ds:schemaRef ds:uri="http://www.w3.org/XML/1998/namespace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50</TotalTime>
  <Words>58</Words>
  <Application>Microsoft Office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Custom Design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illiams</dc:creator>
  <cp:lastModifiedBy>Richard Martin</cp:lastModifiedBy>
  <cp:revision>131</cp:revision>
  <dcterms:created xsi:type="dcterms:W3CDTF">2020-10-13T16:20:28Z</dcterms:created>
  <dcterms:modified xsi:type="dcterms:W3CDTF">2022-10-14T22:14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386C19394DC8445AE088940873BA13C</vt:lpwstr>
  </property>
</Properties>
</file>